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66"/>
    <p:restoredTop sz="94694"/>
  </p:normalViewPr>
  <p:slideViewPr>
    <p:cSldViewPr snapToGrid="0" snapToObjects="1">
      <p:cViewPr varScale="1">
        <p:scale>
          <a:sx n="137" d="100"/>
          <a:sy n="137" d="100"/>
        </p:scale>
        <p:origin x="23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8185013521579262"/>
          <c:y val="0.165033306680178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43</c:f>
              <c:strCache>
                <c:ptCount val="1"/>
                <c:pt idx="0">
                  <c:v>Hugh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5:$J$75</c:f>
                <c:numCache>
                  <c:formatCode>General</c:formatCode>
                  <c:ptCount val="9"/>
                  <c:pt idx="0">
                    <c:v>1.99060768216608E-2</c:v>
                  </c:pt>
                  <c:pt idx="1">
                    <c:v>1.04785704264735E-2</c:v>
                  </c:pt>
                  <c:pt idx="2">
                    <c:v>7.9543781644966904E-3</c:v>
                  </c:pt>
                  <c:pt idx="3">
                    <c:v>2.3537150015421299E-2</c:v>
                  </c:pt>
                  <c:pt idx="4">
                    <c:v>2.42227376106606E-2</c:v>
                  </c:pt>
                  <c:pt idx="5">
                    <c:v>1.16732258749113E-2</c:v>
                  </c:pt>
                  <c:pt idx="6">
                    <c:v>2.31532512886252E-2</c:v>
                  </c:pt>
                  <c:pt idx="7">
                    <c:v>4.2332013255124597E-3</c:v>
                  </c:pt>
                  <c:pt idx="8">
                    <c:v>2.2188957659985899E-3</c:v>
                  </c:pt>
                </c:numCache>
              </c:numRef>
            </c:plus>
            <c:minus>
              <c:numRef>
                <c:f>'Sheet 1 - county estimates'!$B$75:$J$75</c:f>
                <c:numCache>
                  <c:formatCode>General</c:formatCode>
                  <c:ptCount val="9"/>
                  <c:pt idx="0">
                    <c:v>1.99060768216608E-2</c:v>
                  </c:pt>
                  <c:pt idx="1">
                    <c:v>1.04785704264735E-2</c:v>
                  </c:pt>
                  <c:pt idx="2">
                    <c:v>7.9543781644966904E-3</c:v>
                  </c:pt>
                  <c:pt idx="3">
                    <c:v>2.3537150015421299E-2</c:v>
                  </c:pt>
                  <c:pt idx="4">
                    <c:v>2.42227376106606E-2</c:v>
                  </c:pt>
                  <c:pt idx="5">
                    <c:v>1.16732258749113E-2</c:v>
                  </c:pt>
                  <c:pt idx="6">
                    <c:v>2.31532512886252E-2</c:v>
                  </c:pt>
                  <c:pt idx="7">
                    <c:v>4.2332013255124597E-3</c:v>
                  </c:pt>
                  <c:pt idx="8">
                    <c:v>2.218895765998589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42:$J$42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43:$J$43</c:f>
              <c:numCache>
                <c:formatCode>General</c:formatCode>
                <c:ptCount val="9"/>
                <c:pt idx="0">
                  <c:v>0.71417750600441199</c:v>
                </c:pt>
                <c:pt idx="1">
                  <c:v>0.79486569728680401</c:v>
                </c:pt>
                <c:pt idx="2">
                  <c:v>0.88338560714331804</c:v>
                </c:pt>
                <c:pt idx="3">
                  <c:v>0.74153870093510599</c:v>
                </c:pt>
                <c:pt idx="4">
                  <c:v>0.60530128899747204</c:v>
                </c:pt>
                <c:pt idx="5">
                  <c:v>0.82684347442494599</c:v>
                </c:pt>
                <c:pt idx="6">
                  <c:v>0.79052964776725798</c:v>
                </c:pt>
                <c:pt idx="7">
                  <c:v>0.89553824689094597</c:v>
                </c:pt>
                <c:pt idx="8">
                  <c:v>0.96226301229938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7A-354D-95C4-2B959001B0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8359958528900948"/>
          <c:y val="0.2142420032994315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45</c:f>
              <c:strCache>
                <c:ptCount val="1"/>
                <c:pt idx="0">
                  <c:v>Lak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6:$J$76</c:f>
                <c:numCache>
                  <c:formatCode>General</c:formatCode>
                  <c:ptCount val="9"/>
                  <c:pt idx="0">
                    <c:v>4.1373390712573399E-2</c:v>
                  </c:pt>
                  <c:pt idx="1">
                    <c:v>3.0756914011377302E-2</c:v>
                  </c:pt>
                  <c:pt idx="2">
                    <c:v>7.3257062937578096E-2</c:v>
                  </c:pt>
                  <c:pt idx="3">
                    <c:v>4.6198689816032097E-2</c:v>
                  </c:pt>
                  <c:pt idx="4">
                    <c:v>1.5677941595467201E-2</c:v>
                  </c:pt>
                  <c:pt idx="5">
                    <c:v>3.46025593398296E-2</c:v>
                  </c:pt>
                  <c:pt idx="6">
                    <c:v>7.1355055815388202E-2</c:v>
                  </c:pt>
                  <c:pt idx="7">
                    <c:v>3.4995566818399097E-2</c:v>
                  </c:pt>
                  <c:pt idx="8">
                    <c:v>3.34732614988427E-2</c:v>
                  </c:pt>
                </c:numCache>
              </c:numRef>
            </c:plus>
            <c:minus>
              <c:numRef>
                <c:f>'Sheet 1 - county estimates'!$B$76:$J$76</c:f>
                <c:numCache>
                  <c:formatCode>General</c:formatCode>
                  <c:ptCount val="9"/>
                  <c:pt idx="0">
                    <c:v>4.1373390712573399E-2</c:v>
                  </c:pt>
                  <c:pt idx="1">
                    <c:v>3.0756914011377302E-2</c:v>
                  </c:pt>
                  <c:pt idx="2">
                    <c:v>7.3257062937578096E-2</c:v>
                  </c:pt>
                  <c:pt idx="3">
                    <c:v>4.6198689816032097E-2</c:v>
                  </c:pt>
                  <c:pt idx="4">
                    <c:v>1.5677941595467201E-2</c:v>
                  </c:pt>
                  <c:pt idx="5">
                    <c:v>3.46025593398296E-2</c:v>
                  </c:pt>
                  <c:pt idx="6">
                    <c:v>7.1355055815388202E-2</c:v>
                  </c:pt>
                  <c:pt idx="7">
                    <c:v>3.4995566818399097E-2</c:v>
                  </c:pt>
                  <c:pt idx="8">
                    <c:v>3.3473261498842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44:$J$44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45:$J$45</c:f>
              <c:numCache>
                <c:formatCode>General</c:formatCode>
                <c:ptCount val="9"/>
                <c:pt idx="0">
                  <c:v>0.48337316836423699</c:v>
                </c:pt>
                <c:pt idx="1">
                  <c:v>0.49880951271118201</c:v>
                </c:pt>
                <c:pt idx="2">
                  <c:v>0.65445679984294103</c:v>
                </c:pt>
                <c:pt idx="3">
                  <c:v>0.47021672856283397</c:v>
                </c:pt>
                <c:pt idx="4">
                  <c:v>0.38077419556414299</c:v>
                </c:pt>
                <c:pt idx="5">
                  <c:v>0.52483335175061696</c:v>
                </c:pt>
                <c:pt idx="6">
                  <c:v>0.54823622813596495</c:v>
                </c:pt>
                <c:pt idx="7">
                  <c:v>0.62151276131136302</c:v>
                </c:pt>
                <c:pt idx="8">
                  <c:v>0.865779567005387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51-364D-A1F7-676C410A67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7875529592365762"/>
          <c:y val="0.182307119898056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47</c:f>
              <c:strCache>
                <c:ptCount val="1"/>
                <c:pt idx="0">
                  <c:v>Tripp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7:$J$77</c:f>
                <c:numCache>
                  <c:formatCode>General</c:formatCode>
                  <c:ptCount val="9"/>
                  <c:pt idx="0">
                    <c:v>2.9724606353156401E-2</c:v>
                  </c:pt>
                  <c:pt idx="1">
                    <c:v>1.9044999663519201E-2</c:v>
                  </c:pt>
                  <c:pt idx="2">
                    <c:v>1.8785389358922301E-2</c:v>
                  </c:pt>
                  <c:pt idx="3">
                    <c:v>2.9704737361632601E-2</c:v>
                  </c:pt>
                  <c:pt idx="4">
                    <c:v>3.2145623564044802E-2</c:v>
                  </c:pt>
                  <c:pt idx="5">
                    <c:v>1.91812878402715E-2</c:v>
                  </c:pt>
                  <c:pt idx="6">
                    <c:v>4.6396601247530603E-2</c:v>
                  </c:pt>
                  <c:pt idx="7">
                    <c:v>1.2036485959438899E-2</c:v>
                  </c:pt>
                  <c:pt idx="8">
                    <c:v>5.5217278513093101E-3</c:v>
                  </c:pt>
                </c:numCache>
              </c:numRef>
            </c:plus>
            <c:minus>
              <c:numRef>
                <c:f>'Sheet 1 - county estimates'!$B$77:$J$77</c:f>
                <c:numCache>
                  <c:formatCode>General</c:formatCode>
                  <c:ptCount val="9"/>
                  <c:pt idx="0">
                    <c:v>2.9724606353156401E-2</c:v>
                  </c:pt>
                  <c:pt idx="1">
                    <c:v>1.9044999663519201E-2</c:v>
                  </c:pt>
                  <c:pt idx="2">
                    <c:v>1.8785389358922301E-2</c:v>
                  </c:pt>
                  <c:pt idx="3">
                    <c:v>2.9704737361632601E-2</c:v>
                  </c:pt>
                  <c:pt idx="4">
                    <c:v>3.2145623564044802E-2</c:v>
                  </c:pt>
                  <c:pt idx="5">
                    <c:v>1.91812878402715E-2</c:v>
                  </c:pt>
                  <c:pt idx="6">
                    <c:v>4.6396601247530603E-2</c:v>
                  </c:pt>
                  <c:pt idx="7">
                    <c:v>1.2036485959438899E-2</c:v>
                  </c:pt>
                  <c:pt idx="8">
                    <c:v>5.52172785130931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46:$J$46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47:$J$47</c:f>
              <c:numCache>
                <c:formatCode>General</c:formatCode>
                <c:ptCount val="9"/>
                <c:pt idx="0">
                  <c:v>0.65627342507245301</c:v>
                </c:pt>
                <c:pt idx="1">
                  <c:v>0.735992350360272</c:v>
                </c:pt>
                <c:pt idx="2">
                  <c:v>0.84091900402508901</c:v>
                </c:pt>
                <c:pt idx="3">
                  <c:v>0.65899460361393503</c:v>
                </c:pt>
                <c:pt idx="4">
                  <c:v>0.54219740468963795</c:v>
                </c:pt>
                <c:pt idx="5">
                  <c:v>0.757743029952341</c:v>
                </c:pt>
                <c:pt idx="6">
                  <c:v>0.64941887061020498</c:v>
                </c:pt>
                <c:pt idx="7">
                  <c:v>0.78930826516116204</c:v>
                </c:pt>
                <c:pt idx="8">
                  <c:v>0.93980314306513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72-0947-8705-024F922912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958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52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270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25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978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38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10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304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48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425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508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633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E8D3ABB7-A2FC-1C47-A6B1-6652B7D3C012}"/>
              </a:ext>
            </a:extLst>
          </p:cNvPr>
          <p:cNvSpPr/>
          <p:nvPr/>
        </p:nvSpPr>
        <p:spPr>
          <a:xfrm>
            <a:off x="2280877" y="6249831"/>
            <a:ext cx="589779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228600" algn="l"/>
              </a:tabLst>
            </a:pP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2 Figure. Probability of </a:t>
            </a:r>
            <a:r>
              <a:rPr lang="en-US" sz="1200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. </a:t>
            </a:r>
            <a:r>
              <a:rPr lang="en-US" sz="1200" i="1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osichella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iotype 1 occurrence (mean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± SE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at locations in Hughes (A), Lake (B) and Tripp (C) county South Dakota in 2014, 2015 and 2016.</a:t>
            </a:r>
            <a:endParaRPr lang="en-US" sz="14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0F3C1F16-BEF9-8944-8E84-3481F12B8D1F}"/>
              </a:ext>
            </a:extLst>
          </p:cNvPr>
          <p:cNvGrpSpPr/>
          <p:nvPr/>
        </p:nvGrpSpPr>
        <p:grpSpPr>
          <a:xfrm>
            <a:off x="2565386" y="0"/>
            <a:ext cx="4489677" cy="5959982"/>
            <a:chOff x="91323" y="148761"/>
            <a:chExt cx="4489677" cy="5959982"/>
          </a:xfrm>
        </p:grpSpPr>
        <p:sp>
          <p:nvSpPr>
            <p:cNvPr id="11" name="Text Box 18">
              <a:extLst>
                <a:ext uri="{FF2B5EF4-FFF2-40B4-BE49-F238E27FC236}">
                  <a16:creationId xmlns:a16="http://schemas.microsoft.com/office/drawing/2014/main" id="{B739D434-6B5C-AE48-8652-C5EA13703E49}"/>
                </a:ext>
              </a:extLst>
            </p:cNvPr>
            <p:cNvSpPr txBox="1"/>
            <p:nvPr/>
          </p:nvSpPr>
          <p:spPr>
            <a:xfrm rot="10800000">
              <a:off x="91323" y="796620"/>
              <a:ext cx="397669" cy="469582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eaVert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Probability of </a:t>
              </a:r>
              <a:r>
                <a:rPr lang="en-US" sz="1400" b="1" i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A. </a:t>
              </a:r>
              <a:r>
                <a:rPr lang="en-US" sz="1400" b="1" i="1" dirty="0" err="1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toschiella</a:t>
              </a:r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 biotype 1 occurrence (mean </a:t>
              </a:r>
              <a:r>
                <a:rPr lang="en-US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± </a:t>
              </a:r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E)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0BF65A77-A975-4233-B7D4-1C8A8E68DD75}"/>
                </a:ext>
              </a:extLst>
            </p:cNvPr>
            <p:cNvGrpSpPr/>
            <p:nvPr/>
          </p:nvGrpSpPr>
          <p:grpSpPr>
            <a:xfrm>
              <a:off x="488993" y="148761"/>
              <a:ext cx="4092007" cy="5959982"/>
              <a:chOff x="-2" y="340444"/>
              <a:chExt cx="6714453" cy="8619053"/>
            </a:xfrm>
          </p:grpSpPr>
          <p:graphicFrame>
            <p:nvGraphicFramePr>
              <p:cNvPr id="18" name="Chart 17">
                <a:extLst>
                  <a:ext uri="{FF2B5EF4-FFF2-40B4-BE49-F238E27FC236}">
                    <a16:creationId xmlns:a16="http://schemas.microsoft.com/office/drawing/2014/main" id="{D2265C76-B157-4250-9EE0-FDE4A82F7909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700349932"/>
                  </p:ext>
                </p:extLst>
              </p:nvPr>
            </p:nvGraphicFramePr>
            <p:xfrm>
              <a:off x="-2" y="340444"/>
              <a:ext cx="6680427" cy="296250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9" name="Chart 18">
                <a:extLst>
                  <a:ext uri="{FF2B5EF4-FFF2-40B4-BE49-F238E27FC236}">
                    <a16:creationId xmlns:a16="http://schemas.microsoft.com/office/drawing/2014/main" id="{EE99F855-298F-4F48-BAFC-CB56476EFA9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05421405"/>
                  </p:ext>
                </p:extLst>
              </p:nvPr>
            </p:nvGraphicFramePr>
            <p:xfrm>
              <a:off x="34026" y="3221606"/>
              <a:ext cx="6680425" cy="297166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20" name="Chart 19">
                <a:extLst>
                  <a:ext uri="{FF2B5EF4-FFF2-40B4-BE49-F238E27FC236}">
                    <a16:creationId xmlns:a16="http://schemas.microsoft.com/office/drawing/2014/main" id="{A900A803-CBF3-4133-9369-124A32881C3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06186840"/>
                  </p:ext>
                </p:extLst>
              </p:nvPr>
            </p:nvGraphicFramePr>
            <p:xfrm>
              <a:off x="68053" y="6013734"/>
              <a:ext cx="6581104" cy="294576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4085D1A7-D7FF-ED48-9232-DA91D7839AF4}"/>
                </a:ext>
              </a:extLst>
            </p:cNvPr>
            <p:cNvSpPr>
              <a:spLocks noChangeAspect="1"/>
            </p:cNvSpPr>
            <p:nvPr/>
          </p:nvSpPr>
          <p:spPr>
            <a:xfrm flipH="1">
              <a:off x="871662" y="2409372"/>
              <a:ext cx="367979" cy="332844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B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17810CD-ED43-0C49-B2F3-E1E8B1C7AE2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39597" y="440406"/>
              <a:ext cx="300044" cy="260907"/>
            </a:xfrm>
            <a:prstGeom prst="rect">
              <a:avLst/>
            </a:prstGeom>
            <a:noFill/>
            <a:ln w="2667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A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4127DDD1-3769-0C41-934B-13E879283632}"/>
              </a:ext>
            </a:extLst>
          </p:cNvPr>
          <p:cNvGrpSpPr/>
          <p:nvPr/>
        </p:nvGrpSpPr>
        <p:grpSpPr>
          <a:xfrm>
            <a:off x="3392922" y="4212562"/>
            <a:ext cx="2870754" cy="1965915"/>
            <a:chOff x="3392922" y="4212562"/>
            <a:chExt cx="2870754" cy="1965915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0A6CEF86-6C0B-7C44-A55C-FD1852612F8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392922" y="4212562"/>
              <a:ext cx="273583" cy="244391"/>
            </a:xfrm>
            <a:prstGeom prst="rect">
              <a:avLst/>
            </a:prstGeom>
            <a:noFill/>
            <a:ln w="1270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C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 Box 16">
              <a:extLst>
                <a:ext uri="{FF2B5EF4-FFF2-40B4-BE49-F238E27FC236}">
                  <a16:creationId xmlns:a16="http://schemas.microsoft.com/office/drawing/2014/main" id="{309FB0DE-D32E-7F45-9519-7707D20C9089}"/>
                </a:ext>
              </a:extLst>
            </p:cNvPr>
            <p:cNvSpPr txBox="1"/>
            <p:nvPr/>
          </p:nvSpPr>
          <p:spPr>
            <a:xfrm>
              <a:off x="4195875" y="5911301"/>
              <a:ext cx="2067801" cy="267176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ample Month and Year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89928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65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 Smith</dc:creator>
  <cp:lastModifiedBy>Microsoft Office User</cp:lastModifiedBy>
  <cp:revision>13</cp:revision>
  <dcterms:created xsi:type="dcterms:W3CDTF">2019-11-04T20:35:29Z</dcterms:created>
  <dcterms:modified xsi:type="dcterms:W3CDTF">2020-04-10T15:45:26Z</dcterms:modified>
</cp:coreProperties>
</file>